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2640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A72EF-8E24-4064-90B3-9085929539D8}" type="datetimeFigureOut">
              <a:rPr lang="fr-FR" smtClean="0"/>
              <a:pPr/>
              <a:t>12/0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F0865-76FC-4906-BA7E-2E6E7839462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81368" y="604305"/>
          <a:ext cx="6660000" cy="1024880"/>
        </p:xfrm>
        <a:graphic>
          <a:graphicData uri="http://schemas.openxmlformats.org/drawingml/2006/table">
            <a:tbl>
              <a:tblPr/>
              <a:tblGrid>
                <a:gridCol w="665704"/>
                <a:gridCol w="936104"/>
                <a:gridCol w="1080120"/>
                <a:gridCol w="1008112"/>
                <a:gridCol w="1008112"/>
                <a:gridCol w="504056"/>
                <a:gridCol w="506363"/>
                <a:gridCol w="475714"/>
                <a:gridCol w="475715"/>
              </a:tblGrid>
              <a:tr h="49339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articles </a:t>
                      </a:r>
                      <a:r>
                        <a:rPr lang="en-US" sz="10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ass 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centration (µg/m</a:t>
                      </a:r>
                      <a:r>
                        <a:rPr lang="en-US" sz="1000" b="1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articles </a:t>
                      </a:r>
                      <a:r>
                        <a:rPr lang="en-US" sz="10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umber 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centration (#/cm</a:t>
                      </a:r>
                      <a:r>
                        <a:rPr lang="en-US" sz="1000" b="1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r>
                        <a:rPr lang="en-US" sz="1000" b="1" baseline="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baseline="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lveolar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urface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rea (nm</a:t>
                      </a:r>
                      <a:r>
                        <a:rPr lang="en-US" sz="1000" b="1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/cm</a:t>
                      </a:r>
                      <a:r>
                        <a:rPr lang="en-US" sz="1000" b="1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unt median </a:t>
                      </a:r>
                      <a:r>
                        <a:rPr lang="en-US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iameter (nm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O (</a:t>
                      </a:r>
                      <a:r>
                        <a:rPr lang="nl-NL" sz="1000" b="1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pm</a:t>
                      </a: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b="1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Ox</a:t>
                      </a: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(</a:t>
                      </a:r>
                      <a:r>
                        <a:rPr lang="nl-NL" sz="1000" b="1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pm</a:t>
                      </a: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O2 (</a:t>
                      </a:r>
                      <a:r>
                        <a:rPr lang="nl-NL" sz="1000" b="1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pm</a:t>
                      </a: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 (</a:t>
                      </a:r>
                      <a:r>
                        <a:rPr lang="nl-NL" sz="1000" b="1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pm</a:t>
                      </a:r>
                      <a:r>
                        <a:rPr lang="nl-NL" sz="10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fr-FR" sz="1000" b="1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66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an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14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85000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420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9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.2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.9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7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.6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44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tandard </a:t>
                      </a:r>
                      <a:r>
                        <a:rPr lang="nl-NL" sz="1000" dirty="0" err="1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eviation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33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49000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00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8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6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nl-NL" sz="10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</a:t>
                      </a:r>
                      <a:endParaRPr lang="fr-FR" sz="10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81368" y="317018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Diesel exhaust composition during exposure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81368" y="1630705"/>
            <a:ext cx="66600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O: Nitroge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Ox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CO: Carbo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Ox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78</Words>
  <Application>Microsoft Office PowerPoint</Application>
  <PresentationFormat>Affichage à l'écran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AlAdhami</cp:lastModifiedBy>
  <cp:revision>8</cp:revision>
  <dcterms:created xsi:type="dcterms:W3CDTF">2015-06-11T09:05:19Z</dcterms:created>
  <dcterms:modified xsi:type="dcterms:W3CDTF">2016-01-12T09:26:13Z</dcterms:modified>
</cp:coreProperties>
</file>